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.wmf" ContentType="image/x-wmf"/>
  <Override PartName="/ppt/media/image25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8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8D60D-8132-4DF1-8B3A-4F10E769DD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5BD5A-88E3-4239-B686-8FEB59CCA2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67F29-5A96-449F-B475-43F77DB23D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DDBB8-079C-450D-9EFD-6392108609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68247-196B-40E4-BEC0-5D5A3510F1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75E35-4B7B-4F88-A032-864740D6AF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CAC06-B58B-4AA1-9576-BFC7B229C2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186C6-6E7E-4791-BB05-DFB8AF6934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7728F-2C32-4738-BE52-9F8B90AF8C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2023D-FA85-419F-BF1E-A79AFA22DF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8D72F-1C62-4846-B946-D60D5A562A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20D56-61A9-45F9-92DB-BB737BCDFB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C35DBC-9C33-4495-A872-F6C96F1C863F}" type="slidenum">
              <a:rPr b="0" lang="de-A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5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6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8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9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0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1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2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3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4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15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6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7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8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9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20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21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22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23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24.png"/><Relationship Id="rId3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1"/>
          <p:cNvSpPr/>
          <p:nvPr/>
        </p:nvSpPr>
        <p:spPr>
          <a:xfrm>
            <a:off x="0" y="0"/>
            <a:ext cx="25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upplemental dat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9"/>
          <p:cNvSpPr/>
          <p:nvPr/>
        </p:nvSpPr>
        <p:spPr>
          <a:xfrm>
            <a:off x="685800" y="395280"/>
            <a:ext cx="533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etopos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32"/>
          <p:cNvSpPr/>
          <p:nvPr/>
        </p:nvSpPr>
        <p:spPr>
          <a:xfrm>
            <a:off x="0" y="39528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1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32"/>
          <p:cNvSpPr/>
          <p:nvPr/>
        </p:nvSpPr>
        <p:spPr>
          <a:xfrm>
            <a:off x="0" y="381636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1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9"/>
          <p:cNvSpPr/>
          <p:nvPr/>
        </p:nvSpPr>
        <p:spPr>
          <a:xfrm>
            <a:off x="685800" y="3801960"/>
            <a:ext cx="533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doxorubic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1"/>
          <p:cNvSpPr/>
          <p:nvPr/>
        </p:nvSpPr>
        <p:spPr>
          <a:xfrm>
            <a:off x="1011240" y="7218360"/>
            <a:ext cx="4676760" cy="11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Supplemental Figure S1: C7H2/ctr, C7H2/Mcl1L and C7H2/Mcl1L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were treated up to 48 hours with 1µg/ml etoposide (a) or 75 ng/ml doxorubicin (b) and subjected to PI-FACS analyses. Shown is the mean of three independent experiments.  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10" descr=""/>
          <p:cNvPicPr/>
          <p:nvPr/>
        </p:nvPicPr>
        <p:blipFill>
          <a:blip r:embed="rId1"/>
          <a:stretch/>
        </p:blipFill>
        <p:spPr>
          <a:xfrm>
            <a:off x="549360" y="852480"/>
            <a:ext cx="4967280" cy="30718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0" descr=""/>
          <p:cNvPicPr/>
          <p:nvPr/>
        </p:nvPicPr>
        <p:blipFill>
          <a:blip r:embed="rId2"/>
          <a:stretch/>
        </p:blipFill>
        <p:spPr>
          <a:xfrm>
            <a:off x="549360" y="4213080"/>
            <a:ext cx="5040360" cy="3121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Object 4"/>
          <p:cNvGraphicFramePr/>
          <p:nvPr/>
        </p:nvGraphicFramePr>
        <p:xfrm>
          <a:off x="1704960" y="2973240"/>
          <a:ext cx="3025800" cy="505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04960" y="2973240"/>
                    <a:ext cx="3025800" cy="5050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51" name="Text Box 5"/>
          <p:cNvSpPr/>
          <p:nvPr/>
        </p:nvSpPr>
        <p:spPr>
          <a:xfrm>
            <a:off x="2643120" y="623880"/>
            <a:ext cx="1222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C7H2 /Mcl1L</a:t>
            </a: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3575160" y="611280"/>
            <a:ext cx="15094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C7H2/Mcl1L</a:t>
            </a:r>
            <a:r>
              <a:rPr b="1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2830680" y="912960"/>
            <a:ext cx="80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Arial"/>
              </a:rPr>
              <a:t>-        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8"/>
          <p:cNvSpPr/>
          <p:nvPr/>
        </p:nvSpPr>
        <p:spPr>
          <a:xfrm>
            <a:off x="3838680" y="911160"/>
            <a:ext cx="218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Arial"/>
              </a:rPr>
              <a:t>-        +        </a:t>
            </a: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bor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9"/>
          <p:cNvSpPr/>
          <p:nvPr/>
        </p:nvSpPr>
        <p:spPr>
          <a:xfrm>
            <a:off x="1992240" y="62856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C7H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10"/>
          <p:cNvSpPr/>
          <p:nvPr/>
        </p:nvSpPr>
        <p:spPr>
          <a:xfrm>
            <a:off x="2784600" y="9302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11"/>
          <p:cNvSpPr/>
          <p:nvPr/>
        </p:nvSpPr>
        <p:spPr>
          <a:xfrm>
            <a:off x="3720960" y="9302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12"/>
          <p:cNvSpPr/>
          <p:nvPr/>
        </p:nvSpPr>
        <p:spPr>
          <a:xfrm>
            <a:off x="1889280" y="9302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13"/>
          <p:cNvSpPr/>
          <p:nvPr/>
        </p:nvSpPr>
        <p:spPr>
          <a:xfrm>
            <a:off x="1876320" y="915840"/>
            <a:ext cx="80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Arial"/>
              </a:rPr>
              <a:t>-        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0" name="Object 14"/>
          <p:cNvGraphicFramePr/>
          <p:nvPr/>
        </p:nvGraphicFramePr>
        <p:xfrm>
          <a:off x="1704960" y="1825560"/>
          <a:ext cx="3027240" cy="10796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1" name="Object 1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04960" y="1825560"/>
                    <a:ext cx="3027240" cy="10796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62" name="Object 15"/>
          <p:cNvGraphicFramePr/>
          <p:nvPr/>
        </p:nvGraphicFramePr>
        <p:xfrm>
          <a:off x="1704960" y="1233360"/>
          <a:ext cx="3027240" cy="500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3" name="Object 1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704960" y="1233360"/>
                    <a:ext cx="3027240" cy="5000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64" name="Line 16"/>
          <p:cNvSpPr/>
          <p:nvPr/>
        </p:nvSpPr>
        <p:spPr>
          <a:xfrm flipH="1">
            <a:off x="1568160" y="14288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17"/>
          <p:cNvSpPr/>
          <p:nvPr/>
        </p:nvSpPr>
        <p:spPr>
          <a:xfrm flipH="1">
            <a:off x="1555560" y="21240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18"/>
          <p:cNvSpPr/>
          <p:nvPr/>
        </p:nvSpPr>
        <p:spPr>
          <a:xfrm flipH="1">
            <a:off x="1547640" y="251604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19"/>
          <p:cNvSpPr/>
          <p:nvPr/>
        </p:nvSpPr>
        <p:spPr>
          <a:xfrm flipH="1">
            <a:off x="1523880" y="274464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20"/>
          <p:cNvSpPr/>
          <p:nvPr/>
        </p:nvSpPr>
        <p:spPr>
          <a:xfrm flipH="1">
            <a:off x="1547640" y="322272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21"/>
          <p:cNvSpPr/>
          <p:nvPr/>
        </p:nvSpPr>
        <p:spPr>
          <a:xfrm>
            <a:off x="882720" y="12762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40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22"/>
          <p:cNvSpPr/>
          <p:nvPr/>
        </p:nvSpPr>
        <p:spPr>
          <a:xfrm>
            <a:off x="878040" y="1982880"/>
            <a:ext cx="792000" cy="92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2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16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13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23"/>
          <p:cNvSpPr/>
          <p:nvPr/>
        </p:nvSpPr>
        <p:spPr>
          <a:xfrm>
            <a:off x="882720" y="30780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11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2" name="Object 24"/>
          <p:cNvGraphicFramePr/>
          <p:nvPr/>
        </p:nvGraphicFramePr>
        <p:xfrm>
          <a:off x="1703520" y="3554280"/>
          <a:ext cx="3027240" cy="4525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3" name="Object 24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703520" y="3554280"/>
                    <a:ext cx="3027240" cy="4525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74" name="Line 25"/>
          <p:cNvSpPr/>
          <p:nvPr/>
        </p:nvSpPr>
        <p:spPr>
          <a:xfrm flipH="1">
            <a:off x="1549080" y="38131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26"/>
          <p:cNvSpPr/>
          <p:nvPr/>
        </p:nvSpPr>
        <p:spPr>
          <a:xfrm>
            <a:off x="898560" y="365436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38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27"/>
          <p:cNvSpPr/>
          <p:nvPr/>
        </p:nvSpPr>
        <p:spPr>
          <a:xfrm>
            <a:off x="4795920" y="13730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Mcl1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28"/>
          <p:cNvSpPr/>
          <p:nvPr/>
        </p:nvSpPr>
        <p:spPr>
          <a:xfrm>
            <a:off x="4795920" y="194796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Bi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29"/>
          <p:cNvSpPr/>
          <p:nvPr/>
        </p:nvSpPr>
        <p:spPr>
          <a:xfrm>
            <a:off x="4795920" y="309240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Nox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30"/>
          <p:cNvSpPr/>
          <p:nvPr/>
        </p:nvSpPr>
        <p:spPr>
          <a:xfrm>
            <a:off x="4795920" y="366876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32"/>
          <p:cNvSpPr/>
          <p:nvPr/>
        </p:nvSpPr>
        <p:spPr>
          <a:xfrm>
            <a:off x="0" y="2286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feld 29"/>
          <p:cNvSpPr/>
          <p:nvPr/>
        </p:nvSpPr>
        <p:spPr>
          <a:xfrm>
            <a:off x="898560" y="4554360"/>
            <a:ext cx="5051520" cy="97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Supplemental Figure S2: C7H2/ctr, C7H2/Mcl1L and C7H2/Mcl1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were treated for four hours with 200 nM bortezomib (bort). Cell lysates were subjected to immunoblot analyses using antibodies against Mcl1, Bim and Noxa. GAPDH served as loading control.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 Box 5"/>
          <p:cNvSpPr/>
          <p:nvPr/>
        </p:nvSpPr>
        <p:spPr>
          <a:xfrm>
            <a:off x="922320" y="496800"/>
            <a:ext cx="16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 Box 6"/>
          <p:cNvSpPr/>
          <p:nvPr/>
        </p:nvSpPr>
        <p:spPr>
          <a:xfrm>
            <a:off x="2108160" y="496800"/>
            <a:ext cx="213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/Mcl1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7"/>
          <p:cNvSpPr/>
          <p:nvPr/>
        </p:nvSpPr>
        <p:spPr>
          <a:xfrm>
            <a:off x="512640" y="80172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16     24    4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 Box 8"/>
          <p:cNvSpPr/>
          <p:nvPr/>
        </p:nvSpPr>
        <p:spPr>
          <a:xfrm>
            <a:off x="2031840" y="801720"/>
            <a:ext cx="281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16    24     4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 Box 9"/>
          <p:cNvSpPr/>
          <p:nvPr/>
        </p:nvSpPr>
        <p:spPr>
          <a:xfrm>
            <a:off x="3470400" y="80172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 16     24      48     h TRAI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10"/>
          <p:cNvSpPr/>
          <p:nvPr/>
        </p:nvSpPr>
        <p:spPr>
          <a:xfrm>
            <a:off x="3622680" y="457200"/>
            <a:ext cx="23623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/Mcl1L</a:t>
            </a:r>
            <a:r>
              <a:rPr b="1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45"/>
          <p:cNvSpPr/>
          <p:nvPr/>
        </p:nvSpPr>
        <p:spPr>
          <a:xfrm>
            <a:off x="917640" y="279252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 Box 46"/>
          <p:cNvSpPr/>
          <p:nvPr/>
        </p:nvSpPr>
        <p:spPr>
          <a:xfrm>
            <a:off x="2093760" y="2792520"/>
            <a:ext cx="213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/Mcl1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 Box 47"/>
          <p:cNvSpPr/>
          <p:nvPr/>
        </p:nvSpPr>
        <p:spPr>
          <a:xfrm>
            <a:off x="507960" y="309708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 16     24    4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48"/>
          <p:cNvSpPr/>
          <p:nvPr/>
        </p:nvSpPr>
        <p:spPr>
          <a:xfrm>
            <a:off x="2079720" y="3097080"/>
            <a:ext cx="157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 16    24    4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49"/>
          <p:cNvSpPr/>
          <p:nvPr/>
        </p:nvSpPr>
        <p:spPr>
          <a:xfrm>
            <a:off x="3517920" y="3097080"/>
            <a:ext cx="35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0     16     24     48     h CH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3" name="Object 54"/>
          <p:cNvGraphicFramePr/>
          <p:nvPr/>
        </p:nvGraphicFramePr>
        <p:xfrm>
          <a:off x="412920" y="1076400"/>
          <a:ext cx="1439640" cy="360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4" name="Object 5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12920" y="1076400"/>
                    <a:ext cx="143964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95" name="Object 55"/>
          <p:cNvGraphicFramePr/>
          <p:nvPr/>
        </p:nvGraphicFramePr>
        <p:xfrm>
          <a:off x="446040" y="3367080"/>
          <a:ext cx="1440000" cy="360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6" name="Object 5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46040" y="33670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97" name="Object 56"/>
          <p:cNvGraphicFramePr/>
          <p:nvPr/>
        </p:nvGraphicFramePr>
        <p:xfrm>
          <a:off x="1989000" y="3367080"/>
          <a:ext cx="1440000" cy="360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8" name="Object 5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989000" y="33670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99" name="Object 57"/>
          <p:cNvGraphicFramePr/>
          <p:nvPr/>
        </p:nvGraphicFramePr>
        <p:xfrm>
          <a:off x="1955880" y="1076400"/>
          <a:ext cx="1439640" cy="3603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0" name="Object 5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955880" y="1076400"/>
                    <a:ext cx="143964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01" name="Object 58"/>
          <p:cNvGraphicFramePr/>
          <p:nvPr/>
        </p:nvGraphicFramePr>
        <p:xfrm>
          <a:off x="3479760" y="1066680"/>
          <a:ext cx="1440000" cy="3603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02" name="Object 5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479760" y="10666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03" name="Line 65"/>
          <p:cNvSpPr/>
          <p:nvPr/>
        </p:nvSpPr>
        <p:spPr>
          <a:xfrm flipH="1">
            <a:off x="4965480" y="348768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Line 66"/>
          <p:cNvSpPr/>
          <p:nvPr/>
        </p:nvSpPr>
        <p:spPr>
          <a:xfrm flipH="1">
            <a:off x="4965480" y="363996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5" name="Object 67"/>
          <p:cNvGraphicFramePr/>
          <p:nvPr/>
        </p:nvGraphicFramePr>
        <p:xfrm>
          <a:off x="3498840" y="3367080"/>
          <a:ext cx="1440000" cy="3603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06" name="Object 6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498840" y="33670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07" name="Object 68"/>
          <p:cNvGraphicFramePr/>
          <p:nvPr/>
        </p:nvGraphicFramePr>
        <p:xfrm>
          <a:off x="446040" y="3790800"/>
          <a:ext cx="1440000" cy="36036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08" name="Object 6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446040" y="379080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09" name="Object 69"/>
          <p:cNvGraphicFramePr/>
          <p:nvPr/>
        </p:nvGraphicFramePr>
        <p:xfrm>
          <a:off x="412920" y="1504800"/>
          <a:ext cx="1439640" cy="3603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10" name="Object 6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412920" y="1504800"/>
                    <a:ext cx="143964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11" name="Object 70"/>
          <p:cNvGraphicFramePr/>
          <p:nvPr/>
        </p:nvGraphicFramePr>
        <p:xfrm>
          <a:off x="446040" y="4229280"/>
          <a:ext cx="1440000" cy="36036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12" name="Object 7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446040" y="42292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13" name="Object 71"/>
          <p:cNvGraphicFramePr/>
          <p:nvPr/>
        </p:nvGraphicFramePr>
        <p:xfrm>
          <a:off x="412920" y="1938240"/>
          <a:ext cx="1439640" cy="36036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14" name="Object 7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12920" y="1938240"/>
                    <a:ext cx="143964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15" name="Object 72"/>
          <p:cNvGraphicFramePr/>
          <p:nvPr/>
        </p:nvGraphicFramePr>
        <p:xfrm>
          <a:off x="1989000" y="3790800"/>
          <a:ext cx="1440000" cy="36036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16" name="Object 72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1989000" y="379080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17" name="Object 73"/>
          <p:cNvGraphicFramePr/>
          <p:nvPr/>
        </p:nvGraphicFramePr>
        <p:xfrm>
          <a:off x="1963800" y="1504800"/>
          <a:ext cx="1439640" cy="36036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18" name="Object 73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963800" y="1504800"/>
                    <a:ext cx="143964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19" name="Object 74"/>
          <p:cNvGraphicFramePr/>
          <p:nvPr/>
        </p:nvGraphicFramePr>
        <p:xfrm>
          <a:off x="3498840" y="3790800"/>
          <a:ext cx="1440000" cy="36036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120" name="Object 74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3498840" y="379080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21" name="Object 75"/>
          <p:cNvGraphicFramePr/>
          <p:nvPr/>
        </p:nvGraphicFramePr>
        <p:xfrm>
          <a:off x="3479760" y="1504800"/>
          <a:ext cx="1440000" cy="36036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122" name="Object 75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3479760" y="150480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23" name="Object 76"/>
          <p:cNvGraphicFramePr/>
          <p:nvPr/>
        </p:nvGraphicFramePr>
        <p:xfrm>
          <a:off x="3498840" y="4229280"/>
          <a:ext cx="1440000" cy="36036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124" name="Object 76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3498840" y="42292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25" name="Object 77"/>
          <p:cNvGraphicFramePr/>
          <p:nvPr/>
        </p:nvGraphicFramePr>
        <p:xfrm>
          <a:off x="3479760" y="1933560"/>
          <a:ext cx="1440000" cy="36036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126" name="Object 77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3479760" y="193356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127" name="Object 78"/>
          <p:cNvGraphicFramePr/>
          <p:nvPr/>
        </p:nvGraphicFramePr>
        <p:xfrm>
          <a:off x="1989000" y="4229280"/>
          <a:ext cx="1440000" cy="36036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128" name="Object 78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1989000" y="4229280"/>
                    <a:ext cx="144000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29" name="Line 79"/>
          <p:cNvSpPr/>
          <p:nvPr/>
        </p:nvSpPr>
        <p:spPr>
          <a:xfrm flipH="1">
            <a:off x="4965480" y="390996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80"/>
          <p:cNvSpPr/>
          <p:nvPr/>
        </p:nvSpPr>
        <p:spPr>
          <a:xfrm flipH="1">
            <a:off x="4965480" y="406224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 Box 81"/>
          <p:cNvSpPr/>
          <p:nvPr/>
        </p:nvSpPr>
        <p:spPr>
          <a:xfrm>
            <a:off x="4968720" y="195732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Symbol"/>
                <a:ea typeface="Symbol"/>
              </a:rPr>
              <a:t></a:t>
            </a: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 Box 82"/>
          <p:cNvSpPr/>
          <p:nvPr/>
        </p:nvSpPr>
        <p:spPr>
          <a:xfrm>
            <a:off x="5156280" y="1573200"/>
            <a:ext cx="14857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Mcl1L/Mcl1</a:t>
            </a:r>
            <a:r>
              <a:rPr b="0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 Box 83"/>
          <p:cNvSpPr/>
          <p:nvPr/>
        </p:nvSpPr>
        <p:spPr>
          <a:xfrm>
            <a:off x="5156280" y="1125360"/>
            <a:ext cx="14857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pMcl1L/ pMcl1L</a:t>
            </a:r>
            <a:r>
              <a:rPr b="0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Line 84"/>
          <p:cNvSpPr/>
          <p:nvPr/>
        </p:nvSpPr>
        <p:spPr>
          <a:xfrm flipH="1">
            <a:off x="4960800" y="119232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85"/>
          <p:cNvSpPr/>
          <p:nvPr/>
        </p:nvSpPr>
        <p:spPr>
          <a:xfrm flipH="1">
            <a:off x="4960800" y="134460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86"/>
          <p:cNvSpPr/>
          <p:nvPr/>
        </p:nvSpPr>
        <p:spPr>
          <a:xfrm flipH="1">
            <a:off x="4960800" y="161460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Line 87"/>
          <p:cNvSpPr/>
          <p:nvPr/>
        </p:nvSpPr>
        <p:spPr>
          <a:xfrm flipH="1">
            <a:off x="4960800" y="176688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8" name="Object 88"/>
          <p:cNvGraphicFramePr/>
          <p:nvPr/>
        </p:nvGraphicFramePr>
        <p:xfrm>
          <a:off x="1955880" y="1943280"/>
          <a:ext cx="1439640" cy="36036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139" name="Object 88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1955880" y="1943280"/>
                    <a:ext cx="1439640" cy="36036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40" name="Text Box 32"/>
          <p:cNvSpPr/>
          <p:nvPr/>
        </p:nvSpPr>
        <p:spPr>
          <a:xfrm>
            <a:off x="0" y="2286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feld 48"/>
          <p:cNvSpPr/>
          <p:nvPr/>
        </p:nvSpPr>
        <p:spPr>
          <a:xfrm>
            <a:off x="333360" y="4770360"/>
            <a:ext cx="6120000" cy="97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Supplemental Figure S3: Phosphorylation of Mcl1 was analysed in SH-EP/Ctr, SH-EP/Mcl1L and SH-EP/Mcl1L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cells after treatment with either 0.1 µg/ml recombinant TRAIL (upper panel)  or 0.1 µg/ml CH11 (lower panel) for the times indicated.  Tubulin served as loading control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82"/>
          <p:cNvSpPr/>
          <p:nvPr/>
        </p:nvSpPr>
        <p:spPr>
          <a:xfrm>
            <a:off x="5141880" y="3867120"/>
            <a:ext cx="14860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Mcl1L/Mcl1</a:t>
            </a:r>
            <a:r>
              <a:rPr b="0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 Box 83"/>
          <p:cNvSpPr/>
          <p:nvPr/>
        </p:nvSpPr>
        <p:spPr>
          <a:xfrm>
            <a:off x="5141880" y="3419640"/>
            <a:ext cx="14860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pMcl1L/ pMcl1L</a:t>
            </a:r>
            <a:r>
              <a:rPr b="0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 Box 10"/>
          <p:cNvSpPr/>
          <p:nvPr/>
        </p:nvSpPr>
        <p:spPr>
          <a:xfrm>
            <a:off x="3630600" y="2792520"/>
            <a:ext cx="23623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SH-EP/Mcl1L</a:t>
            </a:r>
            <a:r>
              <a:rPr b="1" lang="de-AT" sz="1200" spc="-1" strike="noStrike" baseline="-25000">
                <a:solidFill>
                  <a:srgbClr val="000000"/>
                </a:solidFill>
                <a:latin typeface="Arial"/>
              </a:rPr>
              <a:t>J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 Box 81"/>
          <p:cNvSpPr/>
          <p:nvPr/>
        </p:nvSpPr>
        <p:spPr>
          <a:xfrm>
            <a:off x="4998960" y="42609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Symbol"/>
                <a:ea typeface="Symbol"/>
              </a:rPr>
              <a:t></a:t>
            </a: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ext Box 32"/>
          <p:cNvSpPr/>
          <p:nvPr/>
        </p:nvSpPr>
        <p:spPr>
          <a:xfrm>
            <a:off x="0" y="2286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7" name="Picture 2" descr=""/>
          <p:cNvPicPr/>
          <p:nvPr/>
        </p:nvPicPr>
        <p:blipFill>
          <a:blip r:embed="rId1"/>
          <a:srcRect l="0" t="16302" r="0" b="0"/>
          <a:stretch/>
        </p:blipFill>
        <p:spPr>
          <a:xfrm>
            <a:off x="1219320" y="4524480"/>
            <a:ext cx="2092320" cy="10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48" name="Text Box 5"/>
          <p:cNvSpPr/>
          <p:nvPr/>
        </p:nvSpPr>
        <p:spPr>
          <a:xfrm>
            <a:off x="1366920" y="4168800"/>
            <a:ext cx="366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de-AT" sz="1600" spc="-1" strike="noStrike">
                <a:solidFill>
                  <a:srgbClr val="000000"/>
                </a:solidFill>
                <a:latin typeface="Calibri"/>
              </a:rPr>
              <a:t>-        +        -          +           Bo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Gerade Verbindung 42"/>
          <p:cNvSpPr/>
          <p:nvPr/>
        </p:nvSpPr>
        <p:spPr>
          <a:xfrm>
            <a:off x="2463840" y="4186080"/>
            <a:ext cx="533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Gerade Verbindung 43"/>
          <p:cNvSpPr/>
          <p:nvPr/>
        </p:nvSpPr>
        <p:spPr>
          <a:xfrm>
            <a:off x="1514520" y="4186080"/>
            <a:ext cx="533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feld 44"/>
          <p:cNvSpPr/>
          <p:nvPr/>
        </p:nvSpPr>
        <p:spPr>
          <a:xfrm>
            <a:off x="1503360" y="3851280"/>
            <a:ext cx="752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Calibri"/>
              </a:rPr>
              <a:t>cyt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feld 45"/>
          <p:cNvSpPr/>
          <p:nvPr/>
        </p:nvSpPr>
        <p:spPr>
          <a:xfrm>
            <a:off x="2460600" y="3851280"/>
            <a:ext cx="752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Calibri"/>
              </a:rPr>
              <a:t>nucl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feld 46"/>
          <p:cNvSpPr/>
          <p:nvPr/>
        </p:nvSpPr>
        <p:spPr>
          <a:xfrm>
            <a:off x="3429000" y="4506840"/>
            <a:ext cx="25909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Calibri"/>
              </a:rPr>
              <a:t>EYFP-Mcl1L</a:t>
            </a:r>
            <a:r>
              <a:rPr b="1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1" lang="de-AT" sz="1400" spc="-1" strike="noStrike">
                <a:solidFill>
                  <a:srgbClr val="000000"/>
                </a:solidFill>
                <a:latin typeface="Calibri"/>
              </a:rPr>
              <a:t> (ectopic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feld 47"/>
          <p:cNvSpPr/>
          <p:nvPr/>
        </p:nvSpPr>
        <p:spPr>
          <a:xfrm>
            <a:off x="3429000" y="514656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Calibri"/>
              </a:rPr>
              <a:t>Mcl1L (endogenou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Line 16"/>
          <p:cNvSpPr/>
          <p:nvPr/>
        </p:nvSpPr>
        <p:spPr>
          <a:xfrm flipH="1">
            <a:off x="990360" y="4610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 Box 17"/>
          <p:cNvSpPr/>
          <p:nvPr/>
        </p:nvSpPr>
        <p:spPr>
          <a:xfrm>
            <a:off x="333360" y="4479840"/>
            <a:ext cx="685800" cy="224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Calibri"/>
              </a:rPr>
              <a:t>66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Calibri"/>
              </a:rPr>
              <a:t>40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Calibri"/>
              </a:rPr>
              <a:t>66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Calibri"/>
              </a:rPr>
              <a:t>66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16"/>
          <p:cNvSpPr/>
          <p:nvPr/>
        </p:nvSpPr>
        <p:spPr>
          <a:xfrm flipH="1">
            <a:off x="990360" y="5375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feld 51"/>
          <p:cNvSpPr/>
          <p:nvPr/>
        </p:nvSpPr>
        <p:spPr>
          <a:xfrm>
            <a:off x="3429000" y="575460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Calibri"/>
              </a:rPr>
              <a:t>α</a:t>
            </a:r>
            <a:r>
              <a:rPr b="1" lang="de-AT" sz="1400" spc="-1" strike="noStrike">
                <a:solidFill>
                  <a:srgbClr val="000000"/>
                </a:solidFill>
                <a:latin typeface="Calibri"/>
              </a:rPr>
              <a:t>-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Line 16"/>
          <p:cNvSpPr/>
          <p:nvPr/>
        </p:nvSpPr>
        <p:spPr>
          <a:xfrm flipH="1">
            <a:off x="990360" y="5695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Picture 4" descr=""/>
          <p:cNvPicPr/>
          <p:nvPr/>
        </p:nvPicPr>
        <p:blipFill>
          <a:blip r:embed="rId2"/>
          <a:stretch/>
        </p:blipFill>
        <p:spPr>
          <a:xfrm>
            <a:off x="1220760" y="6113520"/>
            <a:ext cx="2090880" cy="433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1" name="Textfeld 54"/>
          <p:cNvSpPr/>
          <p:nvPr/>
        </p:nvSpPr>
        <p:spPr>
          <a:xfrm>
            <a:off x="3429000" y="621180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Calibri"/>
              </a:rPr>
              <a:t>LaminA/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Line 16"/>
          <p:cNvSpPr/>
          <p:nvPr/>
        </p:nvSpPr>
        <p:spPr>
          <a:xfrm flipH="1">
            <a:off x="993240" y="6292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Picture 5" descr=""/>
          <p:cNvPicPr/>
          <p:nvPr/>
        </p:nvPicPr>
        <p:blipFill>
          <a:blip r:embed="rId3"/>
          <a:stretch/>
        </p:blipFill>
        <p:spPr>
          <a:xfrm>
            <a:off x="1219320" y="5645160"/>
            <a:ext cx="2092320" cy="431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64" name="Picture 10" descr=""/>
          <p:cNvPicPr/>
          <p:nvPr/>
        </p:nvPicPr>
        <p:blipFill>
          <a:blip r:embed="rId4"/>
          <a:stretch/>
        </p:blipFill>
        <p:spPr>
          <a:xfrm>
            <a:off x="587520" y="738360"/>
            <a:ext cx="4794120" cy="2879640"/>
          </a:xfrm>
          <a:prstGeom prst="rect">
            <a:avLst/>
          </a:prstGeom>
          <a:ln w="0">
            <a:noFill/>
          </a:ln>
        </p:spPr>
      </p:pic>
      <p:sp>
        <p:nvSpPr>
          <p:cNvPr id="165" name="Textfeld 21"/>
          <p:cNvSpPr/>
          <p:nvPr/>
        </p:nvSpPr>
        <p:spPr>
          <a:xfrm>
            <a:off x="476280" y="6931080"/>
            <a:ext cx="5689440" cy="146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Supplemental Figure S4: Localization of EYFP-Mcl1L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was analysed by live-cell imaging in SH-EP/EYFP-Mcl1L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cells after treatmet with bortezomib for the times indicated (upper panel). Mitochondria were stained with 300 nM CMXRos. Immuoblot analyses of SH-EP/EYFP-Mcl1L</a:t>
            </a:r>
            <a:r>
              <a:rPr b="0" lang="de-AT" sz="1400" spc="-1" strike="noStrike" baseline="-25000">
                <a:solidFill>
                  <a:srgbClr val="000000"/>
                </a:solidFill>
                <a:latin typeface="Calibri"/>
              </a:rPr>
              <a:t>JAM</a:t>
            </a:r>
            <a:r>
              <a:rPr b="0" lang="de-AT" sz="1400" spc="-1" strike="noStrike">
                <a:solidFill>
                  <a:srgbClr val="000000"/>
                </a:solidFill>
                <a:latin typeface="Calibri"/>
              </a:rPr>
              <a:t> cells after subcellular fractionation and 4 hours bortezomib treatment. Tubulin (cyto) and Lamin (nucleus) served as purification control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5T09:01:44Z</dcterms:created>
  <dc:creator>TKFI</dc:creator>
  <dc:description/>
  <dc:language>en-US</dc:language>
  <cp:lastModifiedBy>Ausserlechner Michael</cp:lastModifiedBy>
  <dcterms:modified xsi:type="dcterms:W3CDTF">2013-07-17T15:23:28Z</dcterms:modified>
  <cp:revision>24</cp:revision>
  <dc:subject/>
  <dc:title>PowerPoint-Präsentation</dc:title>
</cp:coreProperties>
</file>